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775450" cy="990758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D26C36-25ED-4432-9A72-CC12E96A010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4AD2AD-9FE7-4A8A-8722-56EDFFF9601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D37C17-29CB-429A-AEA2-33B3F674E3F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8F17F7-6B94-42AE-BC46-394027AE29D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D04E85-7CAE-4C80-B6E0-2F0F69AB59F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41B033-BB75-4CA8-82D9-CC6F0666C74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FE83B3-C949-4A97-807E-FFBBD85CABB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554E9D-8DE8-4F60-8F26-5FBFD1A58D5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666A67-27FA-4E64-AD01-65CA7F41C27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2B4381-9311-4D85-A5B1-DEA2E556FA2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98D939-EB46-4BA7-9FEC-B27C1BB192D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73C20B-ACB1-44D2-AFCE-1DECBD81DC1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132AD2C-0267-4A82-AC1B-A64C4E64400B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500040" y="1033560"/>
            <a:ext cx="8097840" cy="287280"/>
          </a:xfrm>
          <a:prstGeom prst="rect">
            <a:avLst/>
          </a:prstGeom>
          <a:solidFill>
            <a:srgbClr val="eaeae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5866920" y="1054080"/>
            <a:ext cx="889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Q192 mutatio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2725920" y="1052640"/>
            <a:ext cx="15267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129</a:t>
            </a:r>
            <a:r>
              <a:rPr b="1" lang="en-US" sz="800" spc="-1" strike="noStrike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/I151T double mutatio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4984560" y="790560"/>
            <a:ext cx="846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800" spc="-1" strike="noStrike">
                <a:solidFill>
                  <a:srgbClr val="000000"/>
                </a:solidFill>
                <a:latin typeface="Arial"/>
              </a:rPr>
              <a:t>Strains with</a:t>
            </a:r>
            <a:r>
              <a:rPr b="1" lang="ja-JP" sz="800" spc="-1" strike="noStrike" baseline="30000">
                <a:solidFill>
                  <a:srgbClr val="000000"/>
                </a:solidFill>
                <a:latin typeface="Arial"/>
              </a:rPr>
              <a:t>c,d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500040" y="1576440"/>
            <a:ext cx="8097840" cy="287280"/>
          </a:xfrm>
          <a:prstGeom prst="rect">
            <a:avLst/>
          </a:prstGeom>
          <a:solidFill>
            <a:srgbClr val="eaeae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2727360" y="1882800"/>
            <a:ext cx="214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2727360" y="1609560"/>
            <a:ext cx="214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2732400" y="1336680"/>
            <a:ext cx="2559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Quail/Nanchang/12-340/2000 (H1N1)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[AAN83988]</a:t>
            </a:r>
            <a:r>
              <a:rPr b="1" lang="en-US" sz="800" spc="-1" strike="noStrike" baseline="30000">
                <a:solidFill>
                  <a:srgbClr val="000000"/>
                </a:solidFill>
                <a:latin typeface="Arial"/>
              </a:rPr>
              <a:t>e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5867280" y="1882800"/>
            <a:ext cx="214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5867280" y="1609560"/>
            <a:ext cx="214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5871600" y="1336680"/>
            <a:ext cx="2538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Quail/Nanchang/12-340/2000 (H1N1)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[AAN83988]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498600" y="1293840"/>
            <a:ext cx="809784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498600" y="752400"/>
            <a:ext cx="809784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498600" y="4406760"/>
            <a:ext cx="809784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2579760" y="1030320"/>
            <a:ext cx="60134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441000" y="363600"/>
            <a:ext cx="7962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Table S2. Virus strains encoding HA 129</a:t>
            </a:r>
            <a:r>
              <a:rPr b="1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/I151T and Q192H mutations in avian influenza A virus subtypes.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425160" y="5230800"/>
            <a:ext cx="5377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 baseline="30000">
                <a:solidFill>
                  <a:srgbClr val="000000"/>
                </a:solidFill>
                <a:latin typeface="Arial"/>
              </a:rPr>
              <a:t>a 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Sequence data from the National Center for Biotechnology Information Influenza Virus resource database.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427680" y="5661000"/>
            <a:ext cx="9475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 baseline="30000">
                <a:solidFill>
                  <a:srgbClr val="000000"/>
                </a:solidFill>
                <a:latin typeface="Arial"/>
              </a:rPr>
              <a:t>c 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H5 numbering.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428760" y="5445000"/>
            <a:ext cx="4452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800" spc="-1" strike="noStrike" baseline="30000">
                <a:solidFill>
                  <a:srgbClr val="000000"/>
                </a:solidFill>
                <a:latin typeface="Arial"/>
              </a:rPr>
              <a:t>b </a:t>
            </a:r>
            <a:r>
              <a:rPr b="1" lang="ja-JP" sz="800" spc="-1" strike="noStrike">
                <a:solidFill>
                  <a:srgbClr val="000000"/>
                </a:solidFill>
                <a:latin typeface="Arial"/>
              </a:rPr>
              <a:t>Sequences of viruses from bird species (minimum sequence length 200 aa) are shown.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429480" y="5875200"/>
            <a:ext cx="2936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 baseline="30000">
                <a:solidFill>
                  <a:srgbClr val="000000"/>
                </a:solidFill>
                <a:latin typeface="Arial"/>
              </a:rPr>
              <a:t>d 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ccession number for each virus is shown in brackets.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5867280" y="2982960"/>
            <a:ext cx="214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500040" y="2122560"/>
            <a:ext cx="8097840" cy="287280"/>
          </a:xfrm>
          <a:prstGeom prst="rect">
            <a:avLst/>
          </a:prstGeom>
          <a:solidFill>
            <a:srgbClr val="eaeae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500040" y="2674800"/>
            <a:ext cx="8097840" cy="287640"/>
          </a:xfrm>
          <a:prstGeom prst="rect">
            <a:avLst/>
          </a:prstGeom>
          <a:solidFill>
            <a:srgbClr val="eaeae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2731680" y="2428920"/>
            <a:ext cx="2526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turkey/Minnesota/40550/1987 (H5N2) [ACF25679]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2727360" y="2701800"/>
            <a:ext cx="214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2727360" y="2155680"/>
            <a:ext cx="214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5867280" y="2428920"/>
            <a:ext cx="214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5867280" y="2701800"/>
            <a:ext cx="214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5867280" y="2155680"/>
            <a:ext cx="214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500040" y="3220920"/>
            <a:ext cx="8097840" cy="287280"/>
          </a:xfrm>
          <a:prstGeom prst="rect">
            <a:avLst/>
          </a:prstGeom>
          <a:solidFill>
            <a:srgbClr val="eaeae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500040" y="3773520"/>
            <a:ext cx="8097840" cy="287280"/>
          </a:xfrm>
          <a:prstGeom prst="rect">
            <a:avLst/>
          </a:prstGeom>
          <a:solidFill>
            <a:srgbClr val="eaeae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2727360" y="2981160"/>
            <a:ext cx="214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2727360" y="3527280"/>
            <a:ext cx="214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2727360" y="3800520"/>
            <a:ext cx="214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2727360" y="3254400"/>
            <a:ext cx="214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5867280" y="3527280"/>
            <a:ext cx="214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5867280" y="3800520"/>
            <a:ext cx="214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5867280" y="3254400"/>
            <a:ext cx="214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5867280" y="4633920"/>
            <a:ext cx="214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500040" y="4325760"/>
            <a:ext cx="8097840" cy="287640"/>
          </a:xfrm>
          <a:prstGeom prst="rect">
            <a:avLst/>
          </a:prstGeom>
          <a:solidFill>
            <a:srgbClr val="eaeae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2731680" y="4079880"/>
            <a:ext cx="2911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ruddy turnstone/Delaware/2762/1987 (H11N2) [ABI84442]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2727360" y="4352760"/>
            <a:ext cx="214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5867280" y="4079880"/>
            <a:ext cx="214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5867280" y="4352760"/>
            <a:ext cx="214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500040" y="4871880"/>
            <a:ext cx="8097840" cy="287640"/>
          </a:xfrm>
          <a:prstGeom prst="rect">
            <a:avLst/>
          </a:prstGeom>
          <a:solidFill>
            <a:srgbClr val="eaeae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6" name=""/>
          <p:cNvGrpSpPr/>
          <p:nvPr/>
        </p:nvGrpSpPr>
        <p:grpSpPr>
          <a:xfrm>
            <a:off x="716040" y="1336680"/>
            <a:ext cx="367200" cy="3783960"/>
            <a:chOff x="716040" y="1336680"/>
            <a:chExt cx="367200" cy="3783960"/>
          </a:xfrm>
        </p:grpSpPr>
        <p:sp>
          <p:nvSpPr>
            <p:cNvPr id="87" name=""/>
            <p:cNvSpPr/>
            <p:nvPr/>
          </p:nvSpPr>
          <p:spPr>
            <a:xfrm>
              <a:off x="716040" y="1882440"/>
              <a:ext cx="310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H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716040" y="1609560"/>
              <a:ext cx="310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H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716040" y="1336680"/>
              <a:ext cx="310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H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>
              <a:off x="716040" y="2155680"/>
              <a:ext cx="310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H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>
              <a:off x="716040" y="2428560"/>
              <a:ext cx="310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H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716040" y="2701800"/>
              <a:ext cx="310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H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"/>
            <p:cNvSpPr/>
            <p:nvPr/>
          </p:nvSpPr>
          <p:spPr>
            <a:xfrm>
              <a:off x="716040" y="3254040"/>
              <a:ext cx="310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H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"/>
            <p:cNvSpPr/>
            <p:nvPr/>
          </p:nvSpPr>
          <p:spPr>
            <a:xfrm>
              <a:off x="716040" y="2981160"/>
              <a:ext cx="310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H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"/>
            <p:cNvSpPr/>
            <p:nvPr/>
          </p:nvSpPr>
          <p:spPr>
            <a:xfrm>
              <a:off x="716040" y="3527280"/>
              <a:ext cx="310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H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"/>
            <p:cNvSpPr/>
            <p:nvPr/>
          </p:nvSpPr>
          <p:spPr>
            <a:xfrm>
              <a:off x="716760" y="3800160"/>
              <a:ext cx="366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H1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"/>
            <p:cNvSpPr/>
            <p:nvPr/>
          </p:nvSpPr>
          <p:spPr>
            <a:xfrm>
              <a:off x="716760" y="4079520"/>
              <a:ext cx="366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H1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"/>
            <p:cNvSpPr/>
            <p:nvPr/>
          </p:nvSpPr>
          <p:spPr>
            <a:xfrm>
              <a:off x="716760" y="4352760"/>
              <a:ext cx="366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H1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"/>
            <p:cNvSpPr/>
            <p:nvPr/>
          </p:nvSpPr>
          <p:spPr>
            <a:xfrm>
              <a:off x="716760" y="4905000"/>
              <a:ext cx="366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H1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"/>
            <p:cNvSpPr/>
            <p:nvPr/>
          </p:nvSpPr>
          <p:spPr>
            <a:xfrm>
              <a:off x="716760" y="4632120"/>
              <a:ext cx="366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H1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01" name=""/>
          <p:cNvSpPr/>
          <p:nvPr/>
        </p:nvSpPr>
        <p:spPr>
          <a:xfrm>
            <a:off x="2727360" y="4632480"/>
            <a:ext cx="214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"/>
          <p:cNvSpPr/>
          <p:nvPr/>
        </p:nvSpPr>
        <p:spPr>
          <a:xfrm>
            <a:off x="2727360" y="4905360"/>
            <a:ext cx="214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"/>
          <p:cNvSpPr/>
          <p:nvPr/>
        </p:nvSpPr>
        <p:spPr>
          <a:xfrm>
            <a:off x="5867280" y="4905360"/>
            <a:ext cx="214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"/>
          <p:cNvSpPr/>
          <p:nvPr/>
        </p:nvSpPr>
        <p:spPr>
          <a:xfrm>
            <a:off x="498600" y="5126040"/>
            <a:ext cx="809784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"/>
          <p:cNvSpPr/>
          <p:nvPr/>
        </p:nvSpPr>
        <p:spPr>
          <a:xfrm>
            <a:off x="715680" y="930240"/>
            <a:ext cx="583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Subtyp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"/>
          <p:cNvSpPr/>
          <p:nvPr/>
        </p:nvSpPr>
        <p:spPr>
          <a:xfrm>
            <a:off x="1523520" y="188280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58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"/>
          <p:cNvSpPr/>
          <p:nvPr/>
        </p:nvSpPr>
        <p:spPr>
          <a:xfrm>
            <a:off x="1523520" y="160956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15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"/>
          <p:cNvSpPr/>
          <p:nvPr/>
        </p:nvSpPr>
        <p:spPr>
          <a:xfrm>
            <a:off x="1523520" y="133668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21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"/>
          <p:cNvSpPr/>
          <p:nvPr/>
        </p:nvSpPr>
        <p:spPr>
          <a:xfrm>
            <a:off x="1523520" y="215568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46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"/>
          <p:cNvSpPr/>
          <p:nvPr/>
        </p:nvSpPr>
        <p:spPr>
          <a:xfrm>
            <a:off x="1523520" y="242892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58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"/>
          <p:cNvSpPr/>
          <p:nvPr/>
        </p:nvSpPr>
        <p:spPr>
          <a:xfrm>
            <a:off x="1523520" y="270180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53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"/>
          <p:cNvSpPr/>
          <p:nvPr/>
        </p:nvSpPr>
        <p:spPr>
          <a:xfrm>
            <a:off x="1523520" y="325440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6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"/>
          <p:cNvSpPr/>
          <p:nvPr/>
        </p:nvSpPr>
        <p:spPr>
          <a:xfrm>
            <a:off x="1523520" y="298116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33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"/>
          <p:cNvSpPr/>
          <p:nvPr/>
        </p:nvSpPr>
        <p:spPr>
          <a:xfrm>
            <a:off x="1523880" y="3527280"/>
            <a:ext cx="406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108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"/>
          <p:cNvSpPr/>
          <p:nvPr/>
        </p:nvSpPr>
        <p:spPr>
          <a:xfrm>
            <a:off x="1523520" y="380052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17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"/>
          <p:cNvSpPr/>
          <p:nvPr/>
        </p:nvSpPr>
        <p:spPr>
          <a:xfrm>
            <a:off x="1523520" y="407988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14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"/>
          <p:cNvSpPr/>
          <p:nvPr/>
        </p:nvSpPr>
        <p:spPr>
          <a:xfrm>
            <a:off x="1523520" y="435276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7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"/>
          <p:cNvSpPr/>
          <p:nvPr/>
        </p:nvSpPr>
        <p:spPr>
          <a:xfrm>
            <a:off x="1523520" y="490536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1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"/>
          <p:cNvSpPr/>
          <p:nvPr/>
        </p:nvSpPr>
        <p:spPr>
          <a:xfrm>
            <a:off x="1523520" y="463248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6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"/>
          <p:cNvSpPr/>
          <p:nvPr/>
        </p:nvSpPr>
        <p:spPr>
          <a:xfrm>
            <a:off x="1521360" y="885960"/>
            <a:ext cx="6912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800" spc="-1" strike="noStrike">
                <a:solidFill>
                  <a:srgbClr val="000000"/>
                </a:solidFill>
                <a:latin typeface="Arial"/>
              </a:rPr>
              <a:t>Number of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800" spc="-1" strike="noStrike">
                <a:solidFill>
                  <a:srgbClr val="000000"/>
                </a:solidFill>
                <a:latin typeface="Arial"/>
              </a:rPr>
              <a:t>strains</a:t>
            </a:r>
            <a:r>
              <a:rPr b="1" lang="ja-JP" sz="800" spc="-1" strike="noStrike" baseline="30000">
                <a:solidFill>
                  <a:srgbClr val="000000"/>
                </a:solidFill>
                <a:latin typeface="Arial"/>
              </a:rPr>
              <a:t>a,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"/>
          <p:cNvSpPr/>
          <p:nvPr/>
        </p:nvSpPr>
        <p:spPr>
          <a:xfrm>
            <a:off x="425520" y="6310440"/>
            <a:ext cx="2803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- denotes no virus strains with the indicated mutation.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"/>
          <p:cNvSpPr/>
          <p:nvPr/>
        </p:nvSpPr>
        <p:spPr>
          <a:xfrm>
            <a:off x="426600" y="6091200"/>
            <a:ext cx="5376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 baseline="30000">
                <a:solidFill>
                  <a:srgbClr val="000000"/>
                </a:solidFill>
                <a:latin typeface="Arial"/>
              </a:rPr>
              <a:t>e 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This strain does not have a deletion of 129 residue, but has an adjacent 127 deletion in addition to Thr155.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2-21T05:02:37Z</dcterms:created>
  <dc:creator>nabe</dc:creator>
  <dc:description/>
  <dc:language>en-US</dc:language>
  <cp:lastModifiedBy>nabe</cp:lastModifiedBy>
  <dcterms:modified xsi:type="dcterms:W3CDTF">2011-03-25T08:10:23Z</dcterms:modified>
  <cp:revision>15</cp:revision>
  <dc:subject/>
  <dc:title>スライド 1</dc:title>
</cp:coreProperties>
</file>